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34" d="100"/>
          <a:sy n="134" d="100"/>
        </p:scale>
        <p:origin x="708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hared.zhaw.ch\shared$\pools\t\T-INE-NFP71\G_Dissemin\Wissenschaftliche%20Papers\Paper%20Geisi\Einreichung%20PLOSONE\2.%20Re-submission\Rolle%20Austausch%20Revis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Social interaction (Mean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Rolle Austausch Revised.xlsx]Tabelle1'!$G$12</c:f>
              <c:strCache>
                <c:ptCount val="1"/>
                <c:pt idx="0">
                  <c:v>Gespräch_S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4EF-495A-8F03-86CFF0C81827}"/>
              </c:ext>
            </c:extLst>
          </c:dPt>
          <c:dPt>
            <c:idx val="1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4EF-495A-8F03-86CFF0C81827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4EF-495A-8F03-86CFF0C8182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[Rolle Austausch Revised.xlsx]Tabelle1'!$H$11:$J$11</c:f>
              <c:strCache>
                <c:ptCount val="3"/>
                <c:pt idx="0">
                  <c:v>Negative Comments</c:v>
                </c:pt>
                <c:pt idx="1">
                  <c:v>Positive comments</c:v>
                </c:pt>
                <c:pt idx="2">
                  <c:v>Neutral Comments</c:v>
                </c:pt>
              </c:strCache>
            </c:strRef>
          </c:cat>
          <c:val>
            <c:numRef>
              <c:f>'[Rolle Austausch Revised.xlsx]Tabelle1'!$H$12:$J$12</c:f>
              <c:numCache>
                <c:formatCode>0.0</c:formatCode>
                <c:ptCount val="3"/>
                <c:pt idx="0">
                  <c:v>4.5925925925925926</c:v>
                </c:pt>
                <c:pt idx="1">
                  <c:v>3.625</c:v>
                </c:pt>
                <c:pt idx="2">
                  <c:v>3.43243243243243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4EF-495A-8F03-86CFF0C8182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444"/>
        <c:overlap val="-90"/>
        <c:axId val="653996744"/>
        <c:axId val="653991168"/>
      </c:barChart>
      <c:catAx>
        <c:axId val="6539967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cap="all" spc="12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53991168"/>
        <c:crosses val="autoZero"/>
        <c:auto val="1"/>
        <c:lblAlgn val="ctr"/>
        <c:lblOffset val="100"/>
        <c:noMultiLvlLbl val="0"/>
      </c:catAx>
      <c:valAx>
        <c:axId val="653991168"/>
        <c:scaling>
          <c:orientation val="minMax"/>
          <c:max val="10"/>
          <c:min val="1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53996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559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66883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33865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72264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0689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55040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8456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21003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78589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178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39560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7562D-C54E-409E-9C80-59678724B75C}" type="datetimeFigureOut">
              <a:rPr lang="de-CH" smtClean="0"/>
              <a:t>31.01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DE408-CCA2-4612-8A4A-8D6CE525F9B0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13271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el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de-CH" dirty="0" smtClean="0"/>
              <a:t>S1 </a:t>
            </a:r>
            <a:r>
              <a:rPr lang="de-CH" dirty="0" err="1" smtClean="0"/>
              <a:t>Figure</a:t>
            </a:r>
            <a:endParaRPr lang="de-CH" dirty="0"/>
          </a:p>
        </p:txBody>
      </p:sp>
      <p:graphicFrame>
        <p:nvGraphicFramePr>
          <p:cNvPr id="4" name="Diagramm 3"/>
          <p:cNvGraphicFramePr>
            <a:graphicFrameLocks/>
          </p:cNvGraphicFramePr>
          <p:nvPr/>
        </p:nvGraphicFramePr>
        <p:xfrm>
          <a:off x="2193925" y="2105025"/>
          <a:ext cx="4756150" cy="2647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11287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S1 Figure</vt:lpstr>
    </vt:vector>
  </TitlesOfParts>
  <Company>ZHA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omic Uros (tomi)</dc:creator>
  <cp:lastModifiedBy>Tomic Uros (tomi)</cp:lastModifiedBy>
  <cp:revision>4</cp:revision>
  <cp:lastPrinted>2018-07-30T13:37:09Z</cp:lastPrinted>
  <dcterms:created xsi:type="dcterms:W3CDTF">2018-07-30T13:24:18Z</dcterms:created>
  <dcterms:modified xsi:type="dcterms:W3CDTF">2020-01-31T10:15:05Z</dcterms:modified>
</cp:coreProperties>
</file>